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024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7057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0058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8606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068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5946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8510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4740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269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9580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2600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9EE31-E114-4F98-87E5-755990C2FFE3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0E009-50EB-413C-8CD2-9259EFA61C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2823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90" t="40523" r="29024" b="50000"/>
          <a:stretch/>
        </p:blipFill>
        <p:spPr>
          <a:xfrm>
            <a:off x="2178423" y="3738279"/>
            <a:ext cx="3025588" cy="8471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5223025" y="3838695"/>
            <a:ext cx="233589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CD2AP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/>
          <a:srcRect b="27869"/>
          <a:stretch/>
        </p:blipFill>
        <p:spPr>
          <a:xfrm>
            <a:off x="2178423" y="3079376"/>
            <a:ext cx="3025588" cy="5916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/>
        </p:nvSpPr>
        <p:spPr>
          <a:xfrm>
            <a:off x="5223025" y="3211166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350178" y="2706097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467967" y="270609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091012" y="270609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112988" y="270609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722586" y="270609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683740" y="1874150"/>
            <a:ext cx="2198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CD2A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662031" y="2279938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001773" y="2300309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2427626" y="2618492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3976709" y="2645386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309281" y="457200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5d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9"/>
          <p:cNvSpPr txBox="1"/>
          <p:nvPr/>
        </p:nvSpPr>
        <p:spPr>
          <a:xfrm>
            <a:off x="1624132" y="312685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sp>
        <p:nvSpPr>
          <p:cNvPr id="18" name="文本框 10"/>
          <p:cNvSpPr txBox="1"/>
          <p:nvPr/>
        </p:nvSpPr>
        <p:spPr>
          <a:xfrm>
            <a:off x="1723518" y="338158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</a:p>
        </p:txBody>
      </p:sp>
      <p:cxnSp>
        <p:nvCxnSpPr>
          <p:cNvPr id="19" name="直接连接符 18"/>
          <p:cNvCxnSpPr/>
          <p:nvPr/>
        </p:nvCxnSpPr>
        <p:spPr>
          <a:xfrm>
            <a:off x="2062521" y="329391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2062521" y="351926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15"/>
          <p:cNvSpPr txBox="1"/>
          <p:nvPr/>
        </p:nvSpPr>
        <p:spPr>
          <a:xfrm>
            <a:off x="1624132" y="374119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</a:p>
        </p:txBody>
      </p:sp>
      <p:sp>
        <p:nvSpPr>
          <p:cNvPr id="28" name="文本框 16"/>
          <p:cNvSpPr txBox="1"/>
          <p:nvPr/>
        </p:nvSpPr>
        <p:spPr>
          <a:xfrm>
            <a:off x="1624132" y="401671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cxnSp>
        <p:nvCxnSpPr>
          <p:cNvPr id="29" name="直接连接符 28"/>
          <p:cNvCxnSpPr/>
          <p:nvPr/>
        </p:nvCxnSpPr>
        <p:spPr>
          <a:xfrm>
            <a:off x="2062521" y="389727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2062521" y="422394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38872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53" t="29677" r="19201" b="57420"/>
          <a:stretch/>
        </p:blipFill>
        <p:spPr>
          <a:xfrm>
            <a:off x="3096486" y="4142911"/>
            <a:ext cx="2268505" cy="8030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/>
          <p:cNvSpPr txBox="1"/>
          <p:nvPr/>
        </p:nvSpPr>
        <p:spPr>
          <a:xfrm>
            <a:off x="2160669" y="2788003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278458" y="27880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834268" y="27880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326509" y="27880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854201" y="27880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410628" y="1914811"/>
            <a:ext cx="2198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CD2A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472522" y="2415632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148467" y="2436003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3390518" y="2754186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4357302" y="2755002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8" name="图片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89042" y="3098062"/>
            <a:ext cx="2268000" cy="9885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文本框 30"/>
          <p:cNvSpPr txBox="1"/>
          <p:nvPr/>
        </p:nvSpPr>
        <p:spPr>
          <a:xfrm>
            <a:off x="309281" y="457200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5d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370942" y="4255552"/>
            <a:ext cx="233589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CD2AP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370942" y="3412871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9"/>
          <p:cNvSpPr txBox="1"/>
          <p:nvPr/>
        </p:nvSpPr>
        <p:spPr>
          <a:xfrm>
            <a:off x="2551975" y="327477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sp>
        <p:nvSpPr>
          <p:cNvPr id="18" name="文本框 10"/>
          <p:cNvSpPr txBox="1"/>
          <p:nvPr/>
        </p:nvSpPr>
        <p:spPr>
          <a:xfrm>
            <a:off x="2651361" y="352950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</a:p>
        </p:txBody>
      </p:sp>
      <p:cxnSp>
        <p:nvCxnSpPr>
          <p:cNvPr id="19" name="直接连接符 18"/>
          <p:cNvCxnSpPr/>
          <p:nvPr/>
        </p:nvCxnSpPr>
        <p:spPr>
          <a:xfrm>
            <a:off x="2990364" y="344183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2990364" y="366717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15"/>
          <p:cNvSpPr txBox="1"/>
          <p:nvPr/>
        </p:nvSpPr>
        <p:spPr>
          <a:xfrm>
            <a:off x="2551975" y="414460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</a:p>
        </p:txBody>
      </p:sp>
      <p:sp>
        <p:nvSpPr>
          <p:cNvPr id="22" name="文本框 16"/>
          <p:cNvSpPr txBox="1"/>
          <p:nvPr/>
        </p:nvSpPr>
        <p:spPr>
          <a:xfrm>
            <a:off x="2551975" y="442012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cxnSp>
        <p:nvCxnSpPr>
          <p:cNvPr id="23" name="直接连接符 22"/>
          <p:cNvCxnSpPr/>
          <p:nvPr/>
        </p:nvCxnSpPr>
        <p:spPr>
          <a:xfrm>
            <a:off x="2990364" y="430068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2990364" y="462735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94197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09281" y="457200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5d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35" t="29511" r="52183" b="59069"/>
          <a:stretch/>
        </p:blipFill>
        <p:spPr>
          <a:xfrm>
            <a:off x="3045415" y="4217484"/>
            <a:ext cx="2244599" cy="7246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/>
          <p:cNvSpPr txBox="1"/>
          <p:nvPr/>
        </p:nvSpPr>
        <p:spPr>
          <a:xfrm>
            <a:off x="2069391" y="3078945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187180" y="307894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741358" y="307894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264572" y="307894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778409" y="307894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256550" y="2652786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179027" y="2673157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3257679" y="2991340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4348743" y="3018234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3049395" y="2247313"/>
            <a:ext cx="2198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CD2A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260880" y="4318184"/>
            <a:ext cx="233589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CD2AP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3"/>
          <a:srcRect l="4416" b="29746"/>
          <a:stretch/>
        </p:blipFill>
        <p:spPr>
          <a:xfrm>
            <a:off x="3045742" y="3453737"/>
            <a:ext cx="2246400" cy="6879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/>
          <p:cNvSpPr txBox="1"/>
          <p:nvPr/>
        </p:nvSpPr>
        <p:spPr>
          <a:xfrm>
            <a:off x="5300972" y="3734469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TS1</a:t>
            </a:r>
          </a:p>
        </p:txBody>
      </p:sp>
      <p:sp>
        <p:nvSpPr>
          <p:cNvPr id="18" name="文本框 9"/>
          <p:cNvSpPr txBox="1"/>
          <p:nvPr/>
        </p:nvSpPr>
        <p:spPr>
          <a:xfrm>
            <a:off x="2484740" y="351682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sp>
        <p:nvSpPr>
          <p:cNvPr id="19" name="文本框 10"/>
          <p:cNvSpPr txBox="1"/>
          <p:nvPr/>
        </p:nvSpPr>
        <p:spPr>
          <a:xfrm>
            <a:off x="2584126" y="377154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</a:p>
        </p:txBody>
      </p:sp>
      <p:cxnSp>
        <p:nvCxnSpPr>
          <p:cNvPr id="20" name="直接连接符 19"/>
          <p:cNvCxnSpPr/>
          <p:nvPr/>
        </p:nvCxnSpPr>
        <p:spPr>
          <a:xfrm>
            <a:off x="2923129" y="368387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2923129" y="390922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15"/>
          <p:cNvSpPr txBox="1"/>
          <p:nvPr/>
        </p:nvSpPr>
        <p:spPr>
          <a:xfrm>
            <a:off x="2484740" y="419838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</a:p>
        </p:txBody>
      </p:sp>
      <p:sp>
        <p:nvSpPr>
          <p:cNvPr id="23" name="文本框 16"/>
          <p:cNvSpPr txBox="1"/>
          <p:nvPr/>
        </p:nvSpPr>
        <p:spPr>
          <a:xfrm>
            <a:off x="2484740" y="444701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cxnSp>
        <p:nvCxnSpPr>
          <p:cNvPr id="24" name="直接连接符 23"/>
          <p:cNvCxnSpPr/>
          <p:nvPr/>
        </p:nvCxnSpPr>
        <p:spPr>
          <a:xfrm>
            <a:off x="2923129" y="435447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2923129" y="465424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299849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553" y="699246"/>
            <a:ext cx="3307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5d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9420" y="2264664"/>
            <a:ext cx="3185160" cy="2328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7746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82</Words>
  <Application>Microsoft Office PowerPoint</Application>
  <PresentationFormat>全屏显示(4:3)</PresentationFormat>
  <Paragraphs>4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7</cp:revision>
  <dcterms:created xsi:type="dcterms:W3CDTF">2020-08-31T11:21:48Z</dcterms:created>
  <dcterms:modified xsi:type="dcterms:W3CDTF">2020-10-12T07:32:20Z</dcterms:modified>
</cp:coreProperties>
</file>